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9DAB2F-B180-48EB-8C7C-6FF6CDC35C5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62BBCF-6533-4AF7-8E6F-8DA65E117A5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A5A8C9-47FE-4FFD-8AA3-79F708297C1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A2FA6A-B6BA-4ED3-939A-105F33F7268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82F41A-0F3A-4F73-95AE-40C425F45B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0E45CB-47D1-4140-AD38-57F3B0C07D9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11DF60-ED0F-4019-BF8E-91D0A1CBE2E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FD23D6-B67C-4FDB-A700-C2AF6DC9D36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BE1FD1-F1DD-4E54-9104-4BC69199E37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E31887-62F4-4499-8C6D-40DE7F3582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2E447D-3A27-404F-8CB8-AE90D052E0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1AD9FC-59A8-4800-A99A-B7CF0255DD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UY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UY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UY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B73A008-C573-481E-A482-AE7EFC93F0FA}" type="slidenum">
              <a:rPr b="0" lang="es-UY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3 Imagen" descr="Sup1.tif"/>
          <p:cNvPicPr/>
          <p:nvPr/>
        </p:nvPicPr>
        <p:blipFill>
          <a:blip r:embed="rId1"/>
          <a:stretch/>
        </p:blipFill>
        <p:spPr>
          <a:xfrm>
            <a:off x="1244520" y="1335240"/>
            <a:ext cx="4368960" cy="4403520"/>
          </a:xfrm>
          <a:prstGeom prst="rect">
            <a:avLst/>
          </a:prstGeom>
          <a:ln w="0">
            <a:noFill/>
          </a:ln>
        </p:spPr>
      </p:pic>
      <p:sp>
        <p:nvSpPr>
          <p:cNvPr id="42" name="6 CuadroTexto"/>
          <p:cNvSpPr/>
          <p:nvPr/>
        </p:nvSpPr>
        <p:spPr>
          <a:xfrm>
            <a:off x="2022120" y="309600"/>
            <a:ext cx="28278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1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7 CuadroTexto"/>
          <p:cNvSpPr/>
          <p:nvPr/>
        </p:nvSpPr>
        <p:spPr>
          <a:xfrm>
            <a:off x="0" y="6640560"/>
            <a:ext cx="685800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1 Figure 1. FhTE does not induce signaling through TLR2 or TL4 nor modify moDCs viability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) TLR2 or TLR4-MD2 transfected HEK cells were incubated with either PamCSK4 or LPS, respectively, or immobilized FhTE for two days. Then, IL-8 was evaluated on culture supernatants by ELISA.. B) moDCs were stimulated with coated FhTE for 48 hs,harvested and cell viability was evaluated by flow cytometry using Sytox Blue. A representative Figure of two independent experiments is shown (±SD, indicated by error bars). Asterisks indicate statistically significant differences (*p &lt; 0.05)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4 Imagen" descr="Sup2.tif"/>
          <p:cNvPicPr/>
          <p:nvPr/>
        </p:nvPicPr>
        <p:blipFill>
          <a:blip r:embed="rId1"/>
          <a:stretch/>
        </p:blipFill>
        <p:spPr>
          <a:xfrm>
            <a:off x="285840" y="1254240"/>
            <a:ext cx="6357960" cy="4627440"/>
          </a:xfrm>
          <a:prstGeom prst="rect">
            <a:avLst/>
          </a:prstGeom>
          <a:ln w="0">
            <a:noFill/>
          </a:ln>
        </p:spPr>
      </p:pic>
      <p:sp>
        <p:nvSpPr>
          <p:cNvPr id="45" name="6 CuadroTexto"/>
          <p:cNvSpPr/>
          <p:nvPr/>
        </p:nvSpPr>
        <p:spPr>
          <a:xfrm>
            <a:off x="2022120" y="309600"/>
            <a:ext cx="28278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2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7 CuadroTexto"/>
          <p:cNvSpPr/>
          <p:nvPr/>
        </p:nvSpPr>
        <p:spPr>
          <a:xfrm>
            <a:off x="0" y="7008840"/>
            <a:ext cx="685800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2 Figure 2. MGL does not modulate cytokine production by Pam3CSK4-stimulated mo-DCs when incubated with soluble FhTE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o-DC were overnight incubated with Pam3CSK4 and soluble FhTE and cytokines were detected in the culture supernatants by ELISA. A representative Figure of four independent experiments is shown (±SD, indicated by error bars). Asterisks indicate statistically significant differences (*p &lt; 0.05)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5 Imagen" descr="Sup3.tif"/>
          <p:cNvPicPr/>
          <p:nvPr/>
        </p:nvPicPr>
        <p:blipFill>
          <a:blip r:embed="rId1"/>
          <a:stretch/>
        </p:blipFill>
        <p:spPr>
          <a:xfrm>
            <a:off x="285840" y="1400040"/>
            <a:ext cx="6381720" cy="5767560"/>
          </a:xfrm>
          <a:prstGeom prst="rect">
            <a:avLst/>
          </a:prstGeom>
          <a:ln w="0">
            <a:noFill/>
          </a:ln>
        </p:spPr>
      </p:pic>
      <p:sp>
        <p:nvSpPr>
          <p:cNvPr id="48" name="6 CuadroTexto"/>
          <p:cNvSpPr/>
          <p:nvPr/>
        </p:nvSpPr>
        <p:spPr>
          <a:xfrm>
            <a:off x="2022120" y="309600"/>
            <a:ext cx="28278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3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7 CuadroTexto"/>
          <p:cNvSpPr/>
          <p:nvPr/>
        </p:nvSpPr>
        <p:spPr>
          <a:xfrm>
            <a:off x="0" y="7824960"/>
            <a:ext cx="685800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 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3 Figure 3. Microscopic analyses of PECs and livers form infected animal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) Analyses of MGL2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cells in PECs from 3-week infected and control (non-infected) mice. The bar represents 200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.  B) Analyses of livers from 3-week infected mice showing that MGL2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cells are present in the leukocyte infiltrate (LI) of livers but not in the necrotic areas (N). The bar represents 500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1-02T17:10:13Z</dcterms:created>
  <dc:creator>Teresa Freire</dc:creator>
  <dc:description/>
  <dc:language>en-US</dc:language>
  <cp:lastModifiedBy>Teresa Freire</cp:lastModifiedBy>
  <dcterms:modified xsi:type="dcterms:W3CDTF">2017-01-02T17:17:16Z</dcterms:modified>
  <cp:revision>1</cp:revision>
  <dc:subject/>
  <dc:title>Diapositiva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1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TitleName">
    <vt:lpwstr>Presentation 1.PPT</vt:lpwstr>
  </property>
</Properties>
</file>